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61" r:id="rId4"/>
    <p:sldId id="257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1339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2700F-AA5F-4E09-97AA-DC0D572B0748}" type="datetimeFigureOut">
              <a:rPr lang="ko-KR" altLang="en-US" smtClean="0"/>
              <a:t>2021-02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16045-886B-4D9F-AFD9-F986D03E9D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0041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2700F-AA5F-4E09-97AA-DC0D572B0748}" type="datetimeFigureOut">
              <a:rPr lang="ko-KR" altLang="en-US" smtClean="0"/>
              <a:t>2021-02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16045-886B-4D9F-AFD9-F986D03E9D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3102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2700F-AA5F-4E09-97AA-DC0D572B0748}" type="datetimeFigureOut">
              <a:rPr lang="ko-KR" altLang="en-US" smtClean="0"/>
              <a:t>2021-02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16045-886B-4D9F-AFD9-F986D03E9D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64476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2700F-AA5F-4E09-97AA-DC0D572B0748}" type="datetimeFigureOut">
              <a:rPr lang="ko-KR" altLang="en-US" smtClean="0"/>
              <a:t>2021-02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16045-886B-4D9F-AFD9-F986D03E9D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27263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2700F-AA5F-4E09-97AA-DC0D572B0748}" type="datetimeFigureOut">
              <a:rPr lang="ko-KR" altLang="en-US" smtClean="0"/>
              <a:t>2021-02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16045-886B-4D9F-AFD9-F986D03E9D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5117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2700F-AA5F-4E09-97AA-DC0D572B0748}" type="datetimeFigureOut">
              <a:rPr lang="ko-KR" altLang="en-US" smtClean="0"/>
              <a:t>2021-02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16045-886B-4D9F-AFD9-F986D03E9D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38887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2700F-AA5F-4E09-97AA-DC0D572B0748}" type="datetimeFigureOut">
              <a:rPr lang="ko-KR" altLang="en-US" smtClean="0"/>
              <a:t>2021-02-0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16045-886B-4D9F-AFD9-F986D03E9D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70339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2700F-AA5F-4E09-97AA-DC0D572B0748}" type="datetimeFigureOut">
              <a:rPr lang="ko-KR" altLang="en-US" smtClean="0"/>
              <a:t>2021-02-0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16045-886B-4D9F-AFD9-F986D03E9D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59753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2700F-AA5F-4E09-97AA-DC0D572B0748}" type="datetimeFigureOut">
              <a:rPr lang="ko-KR" altLang="en-US" smtClean="0"/>
              <a:t>2021-02-0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16045-886B-4D9F-AFD9-F986D03E9D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5121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2700F-AA5F-4E09-97AA-DC0D572B0748}" type="datetimeFigureOut">
              <a:rPr lang="ko-KR" altLang="en-US" smtClean="0"/>
              <a:t>2021-02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16045-886B-4D9F-AFD9-F986D03E9D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2513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2700F-AA5F-4E09-97AA-DC0D572B0748}" type="datetimeFigureOut">
              <a:rPr lang="ko-KR" altLang="en-US" smtClean="0"/>
              <a:t>2021-02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216045-886B-4D9F-AFD9-F986D03E9D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949725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72700F-AA5F-4E09-97AA-DC0D572B0748}" type="datetimeFigureOut">
              <a:rPr lang="ko-KR" altLang="en-US" smtClean="0"/>
              <a:t>2021-02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216045-886B-4D9F-AFD9-F986D03E9D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6234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cpark@skku.edu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8BA8991-DC0C-4856-8C08-2DC9B4D618D7}"/>
              </a:ext>
            </a:extLst>
          </p:cNvPr>
          <p:cNvSpPr txBox="1"/>
          <p:nvPr/>
        </p:nvSpPr>
        <p:spPr>
          <a:xfrm>
            <a:off x="705773" y="390901"/>
            <a:ext cx="7364027" cy="49757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b="1" dirty="0"/>
              <a:t>Application of the antitussive agents </a:t>
            </a:r>
            <a:r>
              <a:rPr lang="en-US" altLang="ko-KR" b="1" dirty="0" err="1"/>
              <a:t>oxelaidin</a:t>
            </a:r>
            <a:r>
              <a:rPr lang="en-US" altLang="ko-KR" b="1" dirty="0"/>
              <a:t> and </a:t>
            </a:r>
            <a:r>
              <a:rPr lang="en-US" altLang="ko-KR" b="1" dirty="0" err="1"/>
              <a:t>butamirate</a:t>
            </a:r>
            <a:r>
              <a:rPr lang="en-US" altLang="ko-KR" b="1" dirty="0"/>
              <a:t> as anti-glioma agents</a:t>
            </a:r>
            <a:endParaRPr lang="ko-KR" altLang="ko-KR" dirty="0"/>
          </a:p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 </a:t>
            </a:r>
            <a:endParaRPr lang="en-US" sz="120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ook-Ja Lee</a:t>
            </a:r>
            <a:r>
              <a:rPr lang="en-US" sz="14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1,4</a:t>
            </a:r>
            <a:r>
              <a:rPr lang="en-US" sz="14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eon</a:t>
            </a:r>
            <a:r>
              <a:rPr lang="en-US" sz="14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Yong Yeom</a:t>
            </a:r>
            <a:r>
              <a:rPr lang="en-US" sz="14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1,4</a:t>
            </a:r>
            <a:r>
              <a:rPr lang="en-US" sz="14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Jee</a:t>
            </a:r>
            <a:r>
              <a:rPr lang="en-US" sz="14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Young Lee</a:t>
            </a:r>
            <a:r>
              <a:rPr lang="en-US" sz="14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3</a:t>
            </a:r>
            <a:r>
              <a:rPr lang="en-US" sz="14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and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haehwa</a:t>
            </a:r>
            <a:r>
              <a:rPr lang="en-US" sz="14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Park</a:t>
            </a:r>
            <a:r>
              <a:rPr lang="en-US" sz="14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1,2*</a:t>
            </a:r>
          </a:p>
          <a:p>
            <a:pPr>
              <a:lnSpc>
                <a:spcPct val="200000"/>
              </a:lnSpc>
            </a:pPr>
            <a:r>
              <a:rPr lang="en-US" altLang="ko-KR" sz="1200" b="1" dirty="0"/>
              <a:t>Authors' Affiliations:</a:t>
            </a:r>
            <a:endParaRPr lang="ko-KR" altLang="ko-KR" sz="1200" dirty="0"/>
          </a:p>
          <a:p>
            <a:pPr>
              <a:lnSpc>
                <a:spcPct val="200000"/>
              </a:lnSpc>
            </a:pPr>
            <a:r>
              <a:rPr lang="en-US" altLang="ko-KR" sz="1200" baseline="30000" dirty="0"/>
              <a:t>1 </a:t>
            </a:r>
            <a:r>
              <a:rPr lang="ko-KR" altLang="ko-KR" sz="1200" dirty="0" err="1"/>
              <a:t>Research</a:t>
            </a:r>
            <a:r>
              <a:rPr lang="ko-KR" altLang="ko-KR" sz="1200" dirty="0"/>
              <a:t> </a:t>
            </a:r>
            <a:r>
              <a:rPr lang="ko-KR" altLang="ko-KR" sz="1200" dirty="0" err="1"/>
              <a:t>Institute</a:t>
            </a:r>
            <a:r>
              <a:rPr lang="ko-KR" altLang="ko-KR" sz="1200" dirty="0"/>
              <a:t> </a:t>
            </a:r>
            <a:r>
              <a:rPr lang="ko-KR" altLang="ko-KR" sz="1200" dirty="0" err="1"/>
              <a:t>for</a:t>
            </a:r>
            <a:r>
              <a:rPr lang="ko-KR" altLang="ko-KR" sz="1200" dirty="0"/>
              <a:t> Future </a:t>
            </a:r>
            <a:r>
              <a:rPr lang="ko-KR" altLang="ko-KR" sz="1200" dirty="0" err="1"/>
              <a:t>Medicine</a:t>
            </a:r>
            <a:r>
              <a:rPr lang="ko-KR" altLang="ko-KR" sz="1200" dirty="0"/>
              <a:t>,</a:t>
            </a:r>
            <a:r>
              <a:rPr lang="en-US" altLang="ko-KR" sz="1200" dirty="0"/>
              <a:t> Samsung Medical Center, Seoul, Korea</a:t>
            </a:r>
            <a:endParaRPr lang="ko-KR" altLang="ko-KR" sz="1200" dirty="0"/>
          </a:p>
          <a:p>
            <a:pPr>
              <a:lnSpc>
                <a:spcPct val="200000"/>
              </a:lnSpc>
            </a:pPr>
            <a:r>
              <a:rPr lang="en-US" altLang="ko-KR" sz="1200" baseline="30000" dirty="0"/>
              <a:t>2 </a:t>
            </a:r>
            <a:r>
              <a:rPr lang="ko-KR" altLang="ko-KR" sz="1200" dirty="0" err="1"/>
              <a:t>Department</a:t>
            </a:r>
            <a:r>
              <a:rPr lang="ko-KR" altLang="ko-KR" sz="1200" dirty="0"/>
              <a:t> of </a:t>
            </a:r>
            <a:r>
              <a:rPr lang="ko-KR" altLang="ko-KR" sz="1200" dirty="0" err="1"/>
              <a:t>Medicine</a:t>
            </a:r>
            <a:r>
              <a:rPr lang="ko-KR" altLang="ko-KR" sz="1200" dirty="0"/>
              <a:t>,</a:t>
            </a:r>
            <a:r>
              <a:rPr lang="en-US" altLang="ko-KR" sz="1200" dirty="0"/>
              <a:t> Samsung Medical Center, </a:t>
            </a:r>
            <a:r>
              <a:rPr lang="en-US" altLang="ko-KR" sz="1200" dirty="0" err="1"/>
              <a:t>Sungkyunkwan</a:t>
            </a:r>
            <a:r>
              <a:rPr lang="en-US" altLang="ko-KR" sz="1200" dirty="0"/>
              <a:t> University School of Medicine, Seoul, Korea</a:t>
            </a:r>
            <a:endParaRPr lang="ko-KR" altLang="ko-KR" sz="1200" dirty="0"/>
          </a:p>
          <a:p>
            <a:pPr>
              <a:lnSpc>
                <a:spcPct val="200000"/>
              </a:lnSpc>
            </a:pPr>
            <a:r>
              <a:rPr lang="en-US" altLang="ko-KR" sz="1200" baseline="30000" dirty="0"/>
              <a:t>3 </a:t>
            </a:r>
            <a:r>
              <a:rPr lang="en-US" altLang="ko-KR" sz="1200" dirty="0"/>
              <a:t>New Drug Development Center, Daegu-</a:t>
            </a:r>
            <a:r>
              <a:rPr lang="en-US" altLang="ko-KR" sz="1200" dirty="0" err="1"/>
              <a:t>Gyeongbuk</a:t>
            </a:r>
            <a:r>
              <a:rPr lang="en-US" altLang="ko-KR" sz="1200" dirty="0"/>
              <a:t> Medical Innovation Foundation, Daegu, Korea</a:t>
            </a:r>
            <a:endParaRPr lang="ko-KR" altLang="ko-KR" sz="1200" dirty="0"/>
          </a:p>
          <a:p>
            <a:pPr>
              <a:lnSpc>
                <a:spcPct val="200000"/>
              </a:lnSpc>
            </a:pPr>
            <a:r>
              <a:rPr lang="en-US" altLang="ko-KR" sz="1200" baseline="30000" dirty="0"/>
              <a:t>4 </a:t>
            </a:r>
            <a:r>
              <a:rPr lang="en-US" altLang="ko-KR" sz="1200" dirty="0"/>
              <a:t>These authors contributed equally to this work.</a:t>
            </a:r>
            <a:endParaRPr lang="ko-KR" altLang="ko-KR" sz="1200" dirty="0"/>
          </a:p>
          <a:p>
            <a:pPr>
              <a:lnSpc>
                <a:spcPct val="200000"/>
              </a:lnSpc>
            </a:pPr>
            <a:r>
              <a:rPr lang="en-US" altLang="ko-KR" sz="1200" b="1" dirty="0"/>
              <a:t>Corresponding Author: </a:t>
            </a:r>
            <a:r>
              <a:rPr lang="en-US" altLang="ko-KR" sz="1200" dirty="0" err="1"/>
              <a:t>Chaehwa</a:t>
            </a:r>
            <a:r>
              <a:rPr lang="en-US" altLang="ko-KR" sz="1200" dirty="0"/>
              <a:t> Park, Research Institute for Future Medicine, Samsung Medical Center, </a:t>
            </a:r>
            <a:r>
              <a:rPr lang="en-US" altLang="ko-KR" sz="1200" dirty="0" err="1"/>
              <a:t>Sungkyunkwan</a:t>
            </a:r>
            <a:r>
              <a:rPr lang="en-US" altLang="ko-KR" sz="1200" dirty="0"/>
              <a:t> University School of Medicine, </a:t>
            </a:r>
            <a:r>
              <a:rPr lang="en-US" altLang="ko-KR" sz="1200" dirty="0" err="1"/>
              <a:t>Irwon</a:t>
            </a:r>
            <a:r>
              <a:rPr lang="en-US" altLang="ko-KR" sz="1200" dirty="0"/>
              <a:t>-dong, Seoul, 06351, Korea. </a:t>
            </a:r>
            <a:endParaRPr lang="ko-KR" altLang="ko-KR" sz="1200" dirty="0"/>
          </a:p>
          <a:p>
            <a:pPr>
              <a:lnSpc>
                <a:spcPct val="200000"/>
              </a:lnSpc>
            </a:pPr>
            <a:r>
              <a:rPr lang="en-US" altLang="ko-KR" sz="1200" dirty="0"/>
              <a:t>Phone: 82-2-3410-3458, E-mail: </a:t>
            </a:r>
            <a:r>
              <a:rPr lang="en-US" altLang="ko-KR" sz="1200" u="sng" dirty="0">
                <a:hlinkClick r:id="rId2"/>
              </a:rPr>
              <a:t>cpark@skku.edu</a:t>
            </a:r>
            <a:r>
              <a:rPr lang="en-US" altLang="ko-KR" sz="1200" dirty="0"/>
              <a:t> </a:t>
            </a:r>
            <a:endParaRPr lang="ko-KR" altLang="ko-KR" sz="1200" dirty="0"/>
          </a:p>
          <a:p>
            <a:pPr algn="ctr">
              <a:lnSpc>
                <a:spcPct val="200000"/>
              </a:lnSpc>
              <a:spcAft>
                <a:spcPts val="800"/>
              </a:spcAft>
            </a:pPr>
            <a:endParaRPr lang="en-US" sz="100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9911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4002088" y="1825625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0747093"/>
              </p:ext>
            </p:extLst>
          </p:nvPr>
        </p:nvGraphicFramePr>
        <p:xfrm>
          <a:off x="596516" y="1072751"/>
          <a:ext cx="5720394" cy="26660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1097279">
                  <a:extLst>
                    <a:ext uri="{9D8B030D-6E8A-4147-A177-3AD203B41FA5}">
                      <a16:colId xmlns:a16="http://schemas.microsoft.com/office/drawing/2014/main" val="3256175717"/>
                    </a:ext>
                  </a:extLst>
                </a:gridCol>
                <a:gridCol w="4623115">
                  <a:extLst>
                    <a:ext uri="{9D8B030D-6E8A-4147-A177-3AD203B41FA5}">
                      <a16:colId xmlns:a16="http://schemas.microsoft.com/office/drawing/2014/main" val="2931763530"/>
                    </a:ext>
                  </a:extLst>
                </a:gridCol>
              </a:tblGrid>
              <a:tr h="219228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s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altLang="ko-KR" sz="1100" b="1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</a:t>
                      </a:r>
                      <a:endParaRPr lang="ko-KR" altLang="ko-KR" sz="1100" b="1" kern="100" dirty="0"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0918784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228A for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TG ACT GCG CGT TCA TTG A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2278554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K228A rev</a:t>
                      </a:r>
                      <a:endParaRPr lang="en-US" altLang="ko-KR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CA ATG AAC GCG CAG TCA A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6847839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249A for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GTG TCG TGG CCC AGA TAC G</a:t>
                      </a:r>
                      <a:endParaRPr lang="ko-KR" sz="11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6376040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249A rev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GT ATC TGG GCC ACG ACA C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3410046"/>
                  </a:ext>
                </a:extLst>
              </a:tr>
              <a:tr h="280730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Q250A for</a:t>
                      </a:r>
                      <a:endParaRPr lang="ko-KR" sz="11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CG TGC GCG CGA TAC GCC 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7074081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Q250A rev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GG CGT ATC GCG CGC ACG A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1602049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Tag2B RRAD for</a:t>
                      </a:r>
                      <a:endParaRPr lang="ko-KR" sz="11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GAG CCC GGG CGG ATC CAT GAC CCT GAA CGG </a:t>
                      </a:r>
                      <a:r>
                        <a:rPr lang="en-US" sz="1100" kern="100" dirty="0" err="1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GG</a:t>
                      </a: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kern="100" dirty="0" err="1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GG</a:t>
                      </a: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ko-KR" sz="11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45505477"/>
                  </a:ext>
                </a:extLst>
              </a:tr>
              <a:tr h="242272"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Tag2B RRAD rev</a:t>
                      </a:r>
                      <a:endParaRPr lang="ko-KR" sz="11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GCA GCC CGG GGG ATC CCT AGA GAA CCG AGA GGT CGT</a:t>
                      </a:r>
                      <a:endParaRPr lang="ko-KR" sz="11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9525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026095"/>
                  </a:ext>
                </a:extLst>
              </a:tr>
            </a:tbl>
          </a:graphicData>
        </a:graphic>
      </p:graphicFrame>
      <p:sp>
        <p:nvSpPr>
          <p:cNvPr id="5" name="직사각형 4"/>
          <p:cNvSpPr/>
          <p:nvPr/>
        </p:nvSpPr>
        <p:spPr>
          <a:xfrm>
            <a:off x="596516" y="830237"/>
            <a:ext cx="4392488" cy="253916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1. Primers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92697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23301427"/>
              </p:ext>
            </p:extLst>
          </p:nvPr>
        </p:nvGraphicFramePr>
        <p:xfrm>
          <a:off x="1050504" y="669686"/>
          <a:ext cx="4798205" cy="5867542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1796213">
                  <a:extLst>
                    <a:ext uri="{9D8B030D-6E8A-4147-A177-3AD203B41FA5}">
                      <a16:colId xmlns:a16="http://schemas.microsoft.com/office/drawing/2014/main" val="3157381563"/>
                    </a:ext>
                  </a:extLst>
                </a:gridCol>
                <a:gridCol w="1017917">
                  <a:extLst>
                    <a:ext uri="{9D8B030D-6E8A-4147-A177-3AD203B41FA5}">
                      <a16:colId xmlns:a16="http://schemas.microsoft.com/office/drawing/2014/main" val="4187664568"/>
                    </a:ext>
                  </a:extLst>
                </a:gridCol>
                <a:gridCol w="1069675">
                  <a:extLst>
                    <a:ext uri="{9D8B030D-6E8A-4147-A177-3AD203B41FA5}">
                      <a16:colId xmlns:a16="http://schemas.microsoft.com/office/drawing/2014/main" val="892322532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2180901125"/>
                    </a:ext>
                  </a:extLst>
                </a:gridCol>
              </a:tblGrid>
              <a:tr h="219228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ody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ker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Cat #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돋움" panose="020B0600000101010101" pitchFamily="50" charset="-127"/>
                        <a:ea typeface="돋움" panose="020B0600000101010101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specie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돋움" panose="020B0600000101010101" pitchFamily="50" charset="-127"/>
                        <a:ea typeface="돋움" panose="020B0600000101010101" pitchFamily="50" charset="-127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9720542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GFR</a:t>
                      </a: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Tyr1068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36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u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2192516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GF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3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30884576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GFR</a:t>
                      </a:r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Tyr1101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7619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u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3308451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GF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39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u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4786885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A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7510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6449386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RA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17715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0877436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stat3(Tyr705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45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8644922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TAT3 (tyr705)(32E2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3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u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7436713"/>
                  </a:ext>
                </a:extLst>
              </a:tr>
              <a:tr h="2807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TAT3 (Tyr705)(D3A7)X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45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5175659"/>
                  </a:ext>
                </a:extLst>
              </a:tr>
              <a:tr h="2807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3(F-21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nta cruz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80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u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4575634"/>
                  </a:ext>
                </a:extLst>
              </a:tr>
              <a:tr h="2807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Akt(S473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71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8334333"/>
                  </a:ext>
                </a:extLst>
              </a:tr>
              <a:tr h="2807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k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72</a:t>
                      </a:r>
                      <a:endParaRPr lang="en-US" altLang="ko-K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0282060"/>
                  </a:ext>
                </a:extLst>
              </a:tr>
              <a:tr h="2807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TAT3 (Tyr705)(D3A7)X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45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0001985"/>
                  </a:ext>
                </a:extLst>
              </a:tr>
              <a:tr h="2807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YKDDDDK-Tag(Flag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46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u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9775181"/>
                  </a:ext>
                </a:extLst>
              </a:tr>
              <a:tr h="2807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YKDDDDK-Tag(Flag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68</a:t>
                      </a:r>
                      <a:endParaRPr lang="en-US" altLang="ko-KR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6864908"/>
                  </a:ext>
                </a:extLst>
              </a:tr>
              <a:tr h="2807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ERK(E4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nta cruz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73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u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25762607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KR1(K-23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nta cruz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9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bbi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4216728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-tubulin(B-7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nta cruz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528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u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7220712"/>
                  </a:ext>
                </a:extLst>
              </a:tr>
              <a:tr h="24227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in(C4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nta cruz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-4777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u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돋움" panose="020B0600000101010101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5120735"/>
                  </a:ext>
                </a:extLst>
              </a:tr>
            </a:tbl>
          </a:graphicData>
        </a:graphic>
      </p:graphicFrame>
      <p:sp>
        <p:nvSpPr>
          <p:cNvPr id="4" name="직사각형 3"/>
          <p:cNvSpPr/>
          <p:nvPr/>
        </p:nvSpPr>
        <p:spPr>
          <a:xfrm>
            <a:off x="1050504" y="415770"/>
            <a:ext cx="1303562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2. Antibodies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49861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378911" y="777240"/>
            <a:ext cx="4392488" cy="253916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3. The validated </a:t>
            </a:r>
            <a:r>
              <a:rPr lang="en-US" altLang="ko-KR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qMan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expression assays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5619835"/>
              </p:ext>
            </p:extLst>
          </p:nvPr>
        </p:nvGraphicFramePr>
        <p:xfrm>
          <a:off x="378911" y="1035994"/>
          <a:ext cx="6884531" cy="2838740"/>
        </p:xfrm>
        <a:graphic>
          <a:graphicData uri="http://schemas.openxmlformats.org/drawingml/2006/table">
            <a:tbl>
              <a:tblPr firstRow="1" bandRow="1">
                <a:tableStyleId>{D7AC3CCA-C797-4891-BE02-D94E43425B78}</a:tableStyleId>
              </a:tblPr>
              <a:tblGrid>
                <a:gridCol w="96681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9907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4923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6615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0929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29396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19228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s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say</a:t>
                      </a:r>
                      <a:r>
                        <a:rPr lang="en-US" altLang="ko-KR" sz="11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D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rogated sequence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</a:t>
                      </a:r>
                      <a:r>
                        <a:rPr lang="en-US" altLang="ko-KR" sz="11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100" baseline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oundray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say location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con</a:t>
                      </a:r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ength (</a:t>
                      </a:r>
                      <a:r>
                        <a:rPr lang="en-US" altLang="ko-KR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p</a:t>
                      </a:r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UNB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00357891-s1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2229.2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-1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3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L-1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01050896-m1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197320.1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-4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2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3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00180403-m1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5178.4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3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0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XL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00236329-m1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317919.1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3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57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0730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3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00374280-m1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3150.3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-15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96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2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00608023-m1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0633.2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-3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1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12035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inD1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00765553-m1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53056.2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-4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3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42272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vivin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00153353-m1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_00101227.1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-5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8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1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</a:t>
                      </a:r>
                      <a:endParaRPr lang="ko-KR" alt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4" name="직사각형 3"/>
          <p:cNvSpPr/>
          <p:nvPr/>
        </p:nvSpPr>
        <p:spPr>
          <a:xfrm>
            <a:off x="352706" y="3960985"/>
            <a:ext cx="4392488" cy="253916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apted and modified from http://www.appliedbiosystems.com.hk/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16951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4</TotalTime>
  <Words>472</Words>
  <Application>Microsoft Office PowerPoint</Application>
  <PresentationFormat>화면 슬라이드 쇼(4:3)</PresentationFormat>
  <Paragraphs>166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10" baseType="lpstr">
      <vt:lpstr>돋움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DM500T8Z-AD3A</dc:creator>
  <cp:lastModifiedBy>정 한기</cp:lastModifiedBy>
  <cp:revision>12</cp:revision>
  <dcterms:created xsi:type="dcterms:W3CDTF">2020-12-07T05:26:28Z</dcterms:created>
  <dcterms:modified xsi:type="dcterms:W3CDTF">2021-02-01T13:06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">
    <vt:lpwstr>NSCCustomProperty</vt:lpwstr>
  </property>
  <property fmtid="{D5CDD505-2E9C-101B-9397-08002B2CF9AE}" pid="3" name="NSCPROP_SA">
    <vt:lpwstr>C:\Users\DM500T8Z-AD3A\Desktop\2020\행정관련\buta sci rep\Butamirate supplementary Material120720.pptx</vt:lpwstr>
  </property>
</Properties>
</file>